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2" d="100"/>
          <a:sy n="62" d="100"/>
        </p:scale>
        <p:origin x="4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D785F0-2852-310D-A78E-AA186C9A43F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7A96635-0775-A858-310D-4723F78B81B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D20C08-CCA0-314A-0EBD-219342DE43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459C-0776-4497-BB27-9C693FA8E7F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8946EE-8A7E-0CE2-6B0E-7B401E932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06EEA4-E289-AC76-C9B7-1412A943B8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5A7DE-BCC4-4DAE-9367-CCE2954035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7643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911529-04DB-7E8F-F501-6EE48AA4B5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AC27D8-A2EC-66B1-CF22-516B7DBE16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AF3157-D19E-CB9C-5BA1-CDB6ED7D50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459C-0776-4497-BB27-9C693FA8E7F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4365A8-3A89-5F02-C29F-B45E52F954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67F04B-6604-C36B-7B29-9C1DB87462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5A7DE-BCC4-4DAE-9367-CCE2954035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03158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0268A2B-B9AC-70B2-412D-E77113BD81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2CACB6-F44B-6839-9CE2-7F10406394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206B8E-F31E-724C-BA5B-C22EC41063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459C-0776-4497-BB27-9C693FA8E7F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7D470A-3434-CEE0-F199-DD0BD9EEE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79B33E-90B2-C4B3-E66D-68261280D2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5A7DE-BCC4-4DAE-9367-CCE2954035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078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18C91C-C008-1294-B4E9-3B60032C7F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6130BB-BCB3-BC89-B12F-997E27D636E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5DAB2F-1DC8-834E-F8C6-3C1FB4624F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459C-0776-4497-BB27-9C693FA8E7F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96A481-5099-ED35-EC65-AE69D78A41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268524-B847-B4DC-D5D2-C16B4AB145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5A7DE-BCC4-4DAE-9367-CCE2954035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2797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590E62-F547-84C5-35D6-2C9890965F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66CB47-050F-9D06-4FD9-A5ACA93A5F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BD903A-2A1B-30C3-F5B8-569E7A807F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459C-0776-4497-BB27-9C693FA8E7F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733063-486F-6A94-7DE6-422A3C7F9C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BDB53E-DCA9-FF85-6754-8C7009C155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5A7DE-BCC4-4DAE-9367-CCE2954035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50417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9B4957-4A11-2543-043D-8D6C613925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037215-C8F4-E180-0B5C-B262AA44D3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B0DE11-29C0-8AC1-1AA7-6A938D1836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D062DD-A97A-30A6-3E0A-9BB8B1C9AF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459C-0776-4497-BB27-9C693FA8E7F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090CCA-B9BF-BE37-4B6D-F61422671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7F5846-91DC-6285-826C-5AB34378C4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5A7DE-BCC4-4DAE-9367-CCE2954035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59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1DD8AC-71B8-15EC-7C5A-F6448071B5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6F6F26-6A09-DABE-515C-67D2EC7C33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EDF9D8-026C-1EAA-11D5-D4A1FCF506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1C615D1-D689-ED22-13DA-1E2D783A59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E0806AB-F411-C632-6629-E459DC7ECC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B173886-9BF1-8D7F-1FB7-CFB57D4DCC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459C-0776-4497-BB27-9C693FA8E7F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81563B0-B38B-81BD-F7CD-7F341C809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5E40BEB-2DCE-FCA7-FEDF-F2CB09A9C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5A7DE-BCC4-4DAE-9367-CCE2954035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9661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84D3DE-A326-7258-83DB-81CB4EFCC3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9D31E1E-067F-9E2E-A356-ACA75AE9C8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459C-0776-4497-BB27-9C693FA8E7F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C0853BA-7766-D487-6929-8E72147D9C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60CFDE5-DC58-361F-2411-FF8E9F709C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5A7DE-BCC4-4DAE-9367-CCE2954035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3271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B1D0138-75BD-9A5C-1D8A-F01D57970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459C-0776-4497-BB27-9C693FA8E7F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178490-7F76-F44F-017A-B519DE0F82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3563830-59D0-19ED-4479-1DDB5B08FF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5A7DE-BCC4-4DAE-9367-CCE2954035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11679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184362-ED7D-5953-10A5-BE434904A9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38068B-CFF4-669E-6E5B-D3648AF6E0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AE20D7F-0B66-F4E8-F35C-B656AFAAC1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E8E1C3-6268-A8CC-110F-4013FD9176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459C-0776-4497-BB27-9C693FA8E7F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24EAA2-FCE7-9F17-55FA-C77A885C60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6A5C05-BF84-EB11-1475-787BA5B28C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5A7DE-BCC4-4DAE-9367-CCE2954035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0274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D91876-982C-1AA4-3CB2-C80A9482C9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0AC3105-6501-31E3-7BA9-AD116A5725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7D74EA-0BB9-F6F3-4488-5443B3B132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78E31B-AF56-9FDA-A758-B2793F9130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459C-0776-4497-BB27-9C693FA8E7F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F22703-D0FC-D265-00C4-606907AADE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892E4C-DBE6-AD05-58CB-702FCE07B3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5A7DE-BCC4-4DAE-9367-CCE2954035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9207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DA90D46-52C5-B61F-BA4C-8068275AF7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ED7AC5-5748-B057-A642-2514A52BFA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2C97FC-C793-11E1-C4CD-9B3C4FF6081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E1459C-0776-4497-BB27-9C693FA8E7F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7089BA-6466-C9EF-8E34-251A4218DC0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83075B-284F-4A2E-F156-F693A801B6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65A7DE-BCC4-4DAE-9367-CCE2954035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1477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TextBox 78">
            <a:extLst>
              <a:ext uri="{FF2B5EF4-FFF2-40B4-BE49-F238E27FC236}">
                <a16:creationId xmlns:a16="http://schemas.microsoft.com/office/drawing/2014/main" id="{9A7969B0-626D-49D7-B7FA-57C361B74E88}"/>
              </a:ext>
            </a:extLst>
          </p:cNvPr>
          <p:cNvSpPr txBox="1"/>
          <p:nvPr/>
        </p:nvSpPr>
        <p:spPr>
          <a:xfrm>
            <a:off x="4709134" y="987774"/>
            <a:ext cx="2200440" cy="553998"/>
          </a:xfrm>
          <a:prstGeom prst="rect">
            <a:avLst/>
          </a:prstGeom>
          <a:noFill/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000" b="1"/>
              <a:t>FULL </a:t>
            </a:r>
            <a:r>
              <a:rPr lang="en-GB" sz="1000" b="1" dirty="0"/>
              <a:t>DATA </a:t>
            </a:r>
            <a:r>
              <a:rPr lang="en-GB" sz="1000" b="1"/>
              <a:t>SET </a:t>
            </a:r>
          </a:p>
          <a:p>
            <a:r>
              <a:rPr lang="en-GB" sz="1000" b="1"/>
              <a:t>Examinations </a:t>
            </a:r>
            <a:r>
              <a:rPr lang="en-GB" sz="1000" b="1" dirty="0"/>
              <a:t>n=94,408 </a:t>
            </a:r>
          </a:p>
          <a:p>
            <a:r>
              <a:rPr lang="en-GB" sz="1000" b="1" dirty="0"/>
              <a:t>Screened women n=78,491</a:t>
            </a: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CDD09559-A0C0-4B90-AD26-69CA17B83C6F}"/>
              </a:ext>
            </a:extLst>
          </p:cNvPr>
          <p:cNvCxnSpPr>
            <a:cxnSpLocks/>
          </p:cNvCxnSpPr>
          <p:nvPr/>
        </p:nvCxnSpPr>
        <p:spPr>
          <a:xfrm>
            <a:off x="5558368" y="1571310"/>
            <a:ext cx="0" cy="9302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0A773BC0-D8D4-4E38-AD5B-75A82A0E3BFE}"/>
              </a:ext>
            </a:extLst>
          </p:cNvPr>
          <p:cNvCxnSpPr>
            <a:cxnSpLocks/>
            <a:stCxn id="34" idx="1"/>
          </p:cNvCxnSpPr>
          <p:nvPr/>
        </p:nvCxnSpPr>
        <p:spPr>
          <a:xfrm>
            <a:off x="4679284" y="2004329"/>
            <a:ext cx="0" cy="28883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3" name="TextBox 112">
            <a:extLst>
              <a:ext uri="{FF2B5EF4-FFF2-40B4-BE49-F238E27FC236}">
                <a16:creationId xmlns:a16="http://schemas.microsoft.com/office/drawing/2014/main" id="{D1486DE2-9B08-49BE-8562-32C28DA83D21}"/>
              </a:ext>
            </a:extLst>
          </p:cNvPr>
          <p:cNvSpPr txBox="1"/>
          <p:nvPr/>
        </p:nvSpPr>
        <p:spPr>
          <a:xfrm>
            <a:off x="2994378" y="2308810"/>
            <a:ext cx="2200440" cy="400110"/>
          </a:xfrm>
          <a:prstGeom prst="rect">
            <a:avLst/>
          </a:prstGeom>
          <a:noFill/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000" b="1" dirty="0"/>
              <a:t>Episodes n = 93,416</a:t>
            </a:r>
          </a:p>
          <a:p>
            <a:r>
              <a:rPr lang="en-GB" sz="1000" b="1"/>
              <a:t>(Women </a:t>
            </a:r>
            <a:r>
              <a:rPr lang="en-GB" sz="1000" b="1" dirty="0"/>
              <a:t>n </a:t>
            </a:r>
            <a:r>
              <a:rPr lang="en-GB" sz="1000" b="1"/>
              <a:t>= 78,095)</a:t>
            </a:r>
            <a:endParaRPr lang="en-GB" sz="1000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9A23D41-D1FF-43DC-8ED8-DA5229A05D60}"/>
              </a:ext>
            </a:extLst>
          </p:cNvPr>
          <p:cNvSpPr txBox="1"/>
          <p:nvPr/>
        </p:nvSpPr>
        <p:spPr>
          <a:xfrm>
            <a:off x="6463050" y="2081044"/>
            <a:ext cx="366450" cy="246221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000" b="1" dirty="0"/>
              <a:t>Yes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B9CE06D-ECE9-4F53-B3A0-904DE34D6347}"/>
              </a:ext>
            </a:extLst>
          </p:cNvPr>
          <p:cNvSpPr txBox="1"/>
          <p:nvPr/>
        </p:nvSpPr>
        <p:spPr>
          <a:xfrm>
            <a:off x="4153226" y="1999255"/>
            <a:ext cx="366450" cy="246221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000" b="1" dirty="0"/>
              <a:t>No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D8706BB-B3A9-41B9-A053-DE287402DB2D}"/>
              </a:ext>
            </a:extLst>
          </p:cNvPr>
          <p:cNvSpPr txBox="1"/>
          <p:nvPr/>
        </p:nvSpPr>
        <p:spPr>
          <a:xfrm>
            <a:off x="6055800" y="2308810"/>
            <a:ext cx="2200440" cy="400110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000" b="1"/>
              <a:t>Exam type not specified n </a:t>
            </a:r>
            <a:r>
              <a:rPr lang="en-GB" sz="1000" b="1" dirty="0"/>
              <a:t>= 992</a:t>
            </a:r>
          </a:p>
          <a:p>
            <a:endParaRPr lang="en-GB" sz="1000" b="1" dirty="0"/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334D886A-9673-4C71-BB84-6C6B59899E6D}"/>
              </a:ext>
            </a:extLst>
          </p:cNvPr>
          <p:cNvCxnSpPr>
            <a:cxnSpLocks/>
            <a:stCxn id="34" idx="3"/>
          </p:cNvCxnSpPr>
          <p:nvPr/>
        </p:nvCxnSpPr>
        <p:spPr>
          <a:xfrm flipH="1">
            <a:off x="6437450" y="2004330"/>
            <a:ext cx="2" cy="31496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Flowchart: Decision 33">
            <a:extLst>
              <a:ext uri="{FF2B5EF4-FFF2-40B4-BE49-F238E27FC236}">
                <a16:creationId xmlns:a16="http://schemas.microsoft.com/office/drawing/2014/main" id="{E5323B4D-A3C8-4948-A475-CE84756491CF}"/>
              </a:ext>
            </a:extLst>
          </p:cNvPr>
          <p:cNvSpPr/>
          <p:nvPr/>
        </p:nvSpPr>
        <p:spPr>
          <a:xfrm>
            <a:off x="4679284" y="1698005"/>
            <a:ext cx="1758168" cy="612648"/>
          </a:xfrm>
          <a:prstGeom prst="flowChartDecisio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/>
              <a:t>Examination type missing</a:t>
            </a:r>
            <a:endParaRPr lang="en-GB" sz="1000" dirty="0"/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D94FC5D9-D704-46AF-951C-45CF953FE4BC}"/>
              </a:ext>
            </a:extLst>
          </p:cNvPr>
          <p:cNvCxnSpPr>
            <a:cxnSpLocks/>
          </p:cNvCxnSpPr>
          <p:nvPr/>
        </p:nvCxnSpPr>
        <p:spPr>
          <a:xfrm>
            <a:off x="6504645" y="4769504"/>
            <a:ext cx="0" cy="17042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EDD03AC6-CCF7-41B5-A48E-4E202D2E92F8}"/>
              </a:ext>
            </a:extLst>
          </p:cNvPr>
          <p:cNvSpPr txBox="1"/>
          <p:nvPr/>
        </p:nvSpPr>
        <p:spPr>
          <a:xfrm>
            <a:off x="5184782" y="5259577"/>
            <a:ext cx="366450" cy="246221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000" b="1" dirty="0"/>
              <a:t>Yes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64F3888-0DAC-48C3-A07B-86C9423694A3}"/>
              </a:ext>
            </a:extLst>
          </p:cNvPr>
          <p:cNvSpPr txBox="1"/>
          <p:nvPr/>
        </p:nvSpPr>
        <p:spPr>
          <a:xfrm>
            <a:off x="2344187" y="3542820"/>
            <a:ext cx="1326581" cy="246221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000" b="1" dirty="0"/>
              <a:t>Rejected n= 10,88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FB60E6E-8B3F-45CF-A42F-B704418AA418}"/>
              </a:ext>
            </a:extLst>
          </p:cNvPr>
          <p:cNvSpPr txBox="1"/>
          <p:nvPr/>
        </p:nvSpPr>
        <p:spPr>
          <a:xfrm>
            <a:off x="4234492" y="3566189"/>
            <a:ext cx="1887816" cy="246221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000" b="1" dirty="0"/>
              <a:t>Standard Image set  n= 82,534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B45B2617-7A50-41E3-AD7C-065CE15AC371}"/>
              </a:ext>
            </a:extLst>
          </p:cNvPr>
          <p:cNvCxnSpPr>
            <a:cxnSpLocks/>
          </p:cNvCxnSpPr>
          <p:nvPr/>
        </p:nvCxnSpPr>
        <p:spPr>
          <a:xfrm flipH="1" flipV="1">
            <a:off x="7374235" y="5205140"/>
            <a:ext cx="9494" cy="3452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B193E265-0D7A-47E8-ABCA-3FA732B350E5}"/>
              </a:ext>
            </a:extLst>
          </p:cNvPr>
          <p:cNvSpPr txBox="1"/>
          <p:nvPr/>
        </p:nvSpPr>
        <p:spPr>
          <a:xfrm flipH="1">
            <a:off x="7624498" y="5259577"/>
            <a:ext cx="367759" cy="246221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000" b="1" dirty="0"/>
              <a:t>No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3A9F32B-A498-46B8-9797-77F2B2B534CC}"/>
              </a:ext>
            </a:extLst>
          </p:cNvPr>
          <p:cNvSpPr txBox="1"/>
          <p:nvPr/>
        </p:nvSpPr>
        <p:spPr>
          <a:xfrm>
            <a:off x="3027288" y="4505716"/>
            <a:ext cx="1423918" cy="246221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000" b="1" dirty="0"/>
              <a:t>Other </a:t>
            </a:r>
            <a:r>
              <a:rPr lang="en-GB" sz="1000" b="1"/>
              <a:t>Machine n = </a:t>
            </a:r>
            <a:r>
              <a:rPr lang="en-GB" sz="1000" b="1" dirty="0"/>
              <a:t>626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4141B138-ED96-4B0D-8505-1DA37884E1D2}"/>
              </a:ext>
            </a:extLst>
          </p:cNvPr>
          <p:cNvSpPr txBox="1"/>
          <p:nvPr/>
        </p:nvSpPr>
        <p:spPr>
          <a:xfrm>
            <a:off x="5747780" y="4501301"/>
            <a:ext cx="1513733" cy="246221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000" b="1" dirty="0"/>
              <a:t>On Hologic  n= 81,908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F9336F0-4D6E-4FF3-B330-3F5E5E6794A9}"/>
              </a:ext>
            </a:extLst>
          </p:cNvPr>
          <p:cNvSpPr txBox="1"/>
          <p:nvPr/>
        </p:nvSpPr>
        <p:spPr>
          <a:xfrm>
            <a:off x="6684539" y="5580130"/>
            <a:ext cx="1680972" cy="400110"/>
          </a:xfrm>
          <a:prstGeom prst="rect">
            <a:avLst/>
          </a:prstGeom>
          <a:solidFill>
            <a:schemeClr val="bg1">
              <a:lumMod val="75000"/>
            </a:schemeClr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000" b="1"/>
              <a:t>Study Participants</a:t>
            </a:r>
          </a:p>
          <a:p>
            <a:r>
              <a:rPr lang="en-GB" sz="1000" b="1"/>
              <a:t>n = 80,495</a:t>
            </a:r>
            <a:endParaRPr lang="en-GB" sz="1000" b="1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2BB7CE4-78B2-4E3A-ACF4-8807C4134E4E}"/>
              </a:ext>
            </a:extLst>
          </p:cNvPr>
          <p:cNvSpPr txBox="1"/>
          <p:nvPr/>
        </p:nvSpPr>
        <p:spPr>
          <a:xfrm flipH="1">
            <a:off x="2575924" y="3212977"/>
            <a:ext cx="351725" cy="246221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000" b="1" dirty="0"/>
              <a:t>No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A546B2A0-385C-4ADD-8CDC-6FA8092A6167}"/>
              </a:ext>
            </a:extLst>
          </p:cNvPr>
          <p:cNvSpPr txBox="1"/>
          <p:nvPr/>
        </p:nvSpPr>
        <p:spPr>
          <a:xfrm>
            <a:off x="4839654" y="3212977"/>
            <a:ext cx="433343" cy="246221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000" b="1" dirty="0"/>
              <a:t>Yes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4A74385-CC65-4D37-8BFB-3D67BAB3A4E3}"/>
              </a:ext>
            </a:extLst>
          </p:cNvPr>
          <p:cNvSpPr txBox="1"/>
          <p:nvPr/>
        </p:nvSpPr>
        <p:spPr>
          <a:xfrm>
            <a:off x="4727849" y="5563325"/>
            <a:ext cx="1513733" cy="246221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000" b="1"/>
              <a:t>Yes n =1,413</a:t>
            </a:r>
            <a:endParaRPr lang="en-GB" sz="1000" b="1" dirty="0"/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E8E88567-F69E-4F3F-871A-A08B294A634E}"/>
              </a:ext>
            </a:extLst>
          </p:cNvPr>
          <p:cNvCxnSpPr>
            <a:cxnSpLocks/>
            <a:endCxn id="10" idx="3"/>
          </p:cNvCxnSpPr>
          <p:nvPr/>
        </p:nvCxnSpPr>
        <p:spPr>
          <a:xfrm flipV="1">
            <a:off x="4790459" y="3210106"/>
            <a:ext cx="0" cy="32026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3E14AFD3-2CA3-4A57-85BF-30D53667840A}"/>
              </a:ext>
            </a:extLst>
          </p:cNvPr>
          <p:cNvCxnSpPr>
            <a:cxnSpLocks/>
          </p:cNvCxnSpPr>
          <p:nvPr/>
        </p:nvCxnSpPr>
        <p:spPr>
          <a:xfrm flipV="1">
            <a:off x="5951984" y="4213416"/>
            <a:ext cx="0" cy="31131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Flowchart: Decision 2">
            <a:extLst>
              <a:ext uri="{FF2B5EF4-FFF2-40B4-BE49-F238E27FC236}">
                <a16:creationId xmlns:a16="http://schemas.microsoft.com/office/drawing/2014/main" id="{C1274971-918D-19F2-40CA-932FE53C3247}"/>
              </a:ext>
            </a:extLst>
          </p:cNvPr>
          <p:cNvSpPr/>
          <p:nvPr/>
        </p:nvSpPr>
        <p:spPr>
          <a:xfrm>
            <a:off x="5625561" y="4864047"/>
            <a:ext cx="1758168" cy="612648"/>
          </a:xfrm>
          <a:prstGeom prst="flowChartDecisio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/>
              <a:t>Previous breast cancer?</a:t>
            </a:r>
            <a:endParaRPr lang="en-GB" sz="1000" dirty="0"/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D8B2A10C-91E6-051E-2989-1367547AA8F2}"/>
              </a:ext>
            </a:extLst>
          </p:cNvPr>
          <p:cNvCxnSpPr>
            <a:cxnSpLocks/>
          </p:cNvCxnSpPr>
          <p:nvPr/>
        </p:nvCxnSpPr>
        <p:spPr>
          <a:xfrm flipV="1">
            <a:off x="3935760" y="2708920"/>
            <a:ext cx="0" cy="16263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Flowchart: Decision 9">
            <a:extLst>
              <a:ext uri="{FF2B5EF4-FFF2-40B4-BE49-F238E27FC236}">
                <a16:creationId xmlns:a16="http://schemas.microsoft.com/office/drawing/2014/main" id="{0284B046-644F-9F42-91E9-D11A72889EFF}"/>
              </a:ext>
            </a:extLst>
          </p:cNvPr>
          <p:cNvSpPr/>
          <p:nvPr/>
        </p:nvSpPr>
        <p:spPr>
          <a:xfrm>
            <a:off x="3032291" y="2903781"/>
            <a:ext cx="1758168" cy="612648"/>
          </a:xfrm>
          <a:prstGeom prst="flowChartDecisio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/>
              <a:t>Standard screening set of 4 images</a:t>
            </a:r>
            <a:endParaRPr lang="en-GB" sz="1000" dirty="0"/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A09BAC0F-67C0-755A-1DE4-2D61C0780C26}"/>
              </a:ext>
            </a:extLst>
          </p:cNvPr>
          <p:cNvCxnSpPr>
            <a:cxnSpLocks/>
          </p:cNvCxnSpPr>
          <p:nvPr/>
        </p:nvCxnSpPr>
        <p:spPr>
          <a:xfrm flipV="1">
            <a:off x="5077419" y="3830798"/>
            <a:ext cx="0" cy="16263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Flowchart: Decision 37">
            <a:extLst>
              <a:ext uri="{FF2B5EF4-FFF2-40B4-BE49-F238E27FC236}">
                <a16:creationId xmlns:a16="http://schemas.microsoft.com/office/drawing/2014/main" id="{97B4F2EA-FD75-61A3-97C2-EBC990A84C48}"/>
              </a:ext>
            </a:extLst>
          </p:cNvPr>
          <p:cNvSpPr/>
          <p:nvPr/>
        </p:nvSpPr>
        <p:spPr>
          <a:xfrm>
            <a:off x="4198335" y="3912086"/>
            <a:ext cx="1758168" cy="612648"/>
          </a:xfrm>
          <a:prstGeom prst="flowChartDecisio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/>
              <a:t>Hologic machine?</a:t>
            </a:r>
            <a:endParaRPr lang="en-GB" sz="1000" dirty="0"/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7CCBF59B-7FB5-5B17-73C1-4F3B900B7BFC}"/>
              </a:ext>
            </a:extLst>
          </p:cNvPr>
          <p:cNvCxnSpPr>
            <a:cxnSpLocks/>
          </p:cNvCxnSpPr>
          <p:nvPr/>
        </p:nvCxnSpPr>
        <p:spPr>
          <a:xfrm flipV="1">
            <a:off x="3071664" y="3212977"/>
            <a:ext cx="0" cy="32026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465EB043-81B5-D1B6-63CF-5B67DA93A8D3}"/>
              </a:ext>
            </a:extLst>
          </p:cNvPr>
          <p:cNvCxnSpPr>
            <a:cxnSpLocks/>
          </p:cNvCxnSpPr>
          <p:nvPr/>
        </p:nvCxnSpPr>
        <p:spPr>
          <a:xfrm flipV="1">
            <a:off x="4223792" y="4221088"/>
            <a:ext cx="0" cy="31131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64C7BA8D-EF0C-2802-F8BD-095160C221D9}"/>
              </a:ext>
            </a:extLst>
          </p:cNvPr>
          <p:cNvSpPr txBox="1"/>
          <p:nvPr/>
        </p:nvSpPr>
        <p:spPr>
          <a:xfrm>
            <a:off x="6004108" y="4155403"/>
            <a:ext cx="433343" cy="246221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000" b="1" dirty="0"/>
              <a:t>Yes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6EE28ED7-E552-73BE-1BD6-04A698E9D332}"/>
              </a:ext>
            </a:extLst>
          </p:cNvPr>
          <p:cNvSpPr txBox="1"/>
          <p:nvPr/>
        </p:nvSpPr>
        <p:spPr>
          <a:xfrm flipH="1">
            <a:off x="3831734" y="4136189"/>
            <a:ext cx="351725" cy="246221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000" b="1" dirty="0"/>
              <a:t>No</a:t>
            </a: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EAE97220-00D9-A30C-C05A-800B7D748AD9}"/>
              </a:ext>
            </a:extLst>
          </p:cNvPr>
          <p:cNvCxnSpPr>
            <a:cxnSpLocks/>
          </p:cNvCxnSpPr>
          <p:nvPr/>
        </p:nvCxnSpPr>
        <p:spPr>
          <a:xfrm flipH="1" flipV="1">
            <a:off x="5644649" y="5218104"/>
            <a:ext cx="9494" cy="3452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" name="Rectangle 3">
            <a:extLst>
              <a:ext uri="{FF2B5EF4-FFF2-40B4-BE49-F238E27FC236}">
                <a16:creationId xmlns:a16="http://schemas.microsoft.com/office/drawing/2014/main" id="{D586D2D4-5F8D-4E89-8304-47A7A68A0FEF}"/>
              </a:ext>
            </a:extLst>
          </p:cNvPr>
          <p:cNvSpPr/>
          <p:nvPr/>
        </p:nvSpPr>
        <p:spPr>
          <a:xfrm>
            <a:off x="2364189" y="6387639"/>
            <a:ext cx="6115050" cy="1860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r>
              <a:rPr lang="en-GB" sz="12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ure 1 Tree of exclusions from study</a:t>
            </a:r>
            <a:endParaRPr lang="en-GB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36935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90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ree of Exclusions MAMMOGRAPHY descriptive studies</dc:title>
  <dc:creator>Sue</dc:creator>
  <cp:lastModifiedBy>Sue</cp:lastModifiedBy>
  <cp:revision>2</cp:revision>
  <dcterms:created xsi:type="dcterms:W3CDTF">2023-03-13T23:12:20Z</dcterms:created>
  <dcterms:modified xsi:type="dcterms:W3CDTF">2023-03-13T23:15:03Z</dcterms:modified>
</cp:coreProperties>
</file>